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8"/>
  </p:notesMasterIdLst>
  <p:sldIdLst>
    <p:sldId id="262" r:id="rId2"/>
    <p:sldId id="274" r:id="rId3"/>
    <p:sldId id="269" r:id="rId4"/>
    <p:sldId id="271" r:id="rId5"/>
    <p:sldId id="273" r:id="rId6"/>
    <p:sldId id="270" r:id="rId7"/>
  </p:sldIdLst>
  <p:sldSz cx="6858000" cy="91138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F9500A-D320-F547-BF07-E0473B243CF0}" v="20" dt="2026-01-16T16:42:09.02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93"/>
    <p:restoredTop sz="94694"/>
  </p:normalViewPr>
  <p:slideViewPr>
    <p:cSldViewPr snapToGrid="0">
      <p:cViewPr varScale="1">
        <p:scale>
          <a:sx n="91" d="100"/>
          <a:sy n="91" d="100"/>
        </p:scale>
        <p:origin x="35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E713BA-4FA7-EC4D-9366-1ECD90B7EDF7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1143000"/>
            <a:ext cx="2320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99FEB-089F-A54E-92CB-6AD73CB9AB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5633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1pPr>
    <a:lvl2pPr marL="402282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2pPr>
    <a:lvl3pPr marL="804565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3pPr>
    <a:lvl4pPr marL="1206848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4pPr>
    <a:lvl5pPr marL="1609131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5pPr>
    <a:lvl6pPr marL="2011413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6pPr>
    <a:lvl7pPr marL="2413695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7pPr>
    <a:lvl8pPr marL="2815978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8pPr>
    <a:lvl9pPr marL="3218261" algn="l" defTabSz="804565" rtl="0" eaLnBrk="1" latinLnBrk="0" hangingPunct="1">
      <a:defRPr sz="105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F90A8E-071E-308B-3BD6-4EF8B631BE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C379BCAE-BDE6-2ABA-2CEF-FCCA20BA710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78C31F41-A501-F4AF-F5C1-03A46C10FF6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687B87-F098-E535-AA4B-282B76F1488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5147E1-ED3B-4752-B07B-682455BCE82B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3072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1AFE6A1-0819-DC63-8BCC-58D96FF8F38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6081A2C-B1B0-ED6D-7BB5-D9D066FD887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38196B82-C90A-8FDD-7B69-60D776150C3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64436F-DAD5-1CFC-038E-6D214E12E89F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35147E1-ED3B-4752-B07B-682455BCE82B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36004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1548"/>
            <a:ext cx="5829300" cy="317296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86875"/>
            <a:ext cx="5143500" cy="2200401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321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100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5228"/>
            <a:ext cx="1478756" cy="77235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5228"/>
            <a:ext cx="4350544" cy="77235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750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067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2133"/>
            <a:ext cx="5915025" cy="379110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99101"/>
            <a:ext cx="5915025" cy="1993651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442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26138"/>
            <a:ext cx="2914650" cy="578264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26138"/>
            <a:ext cx="2914650" cy="578264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6430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5230"/>
            <a:ext cx="5915025" cy="176158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34157"/>
            <a:ext cx="2901255" cy="10949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29082"/>
            <a:ext cx="2901255" cy="48965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34157"/>
            <a:ext cx="2915543" cy="109492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29082"/>
            <a:ext cx="2915543" cy="489657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8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672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82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7589"/>
            <a:ext cx="2211884" cy="212656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2226"/>
            <a:ext cx="3471863" cy="647673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34151"/>
            <a:ext cx="2211884" cy="50653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3348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7589"/>
            <a:ext cx="2211884" cy="212656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2226"/>
            <a:ext cx="3471863" cy="647673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34151"/>
            <a:ext cx="2211884" cy="506535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07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5230"/>
            <a:ext cx="5915025" cy="17615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26138"/>
            <a:ext cx="5915025" cy="57826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47180"/>
            <a:ext cx="1543050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41D01C7-30AD-3E43-8CD6-9A11A9BAAB54}" type="datetimeFigureOut">
              <a:rPr lang="en-US" smtClean="0"/>
              <a:t>2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47180"/>
            <a:ext cx="2314575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47180"/>
            <a:ext cx="1543050" cy="485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7DAF39C-0E1E-D543-AE4B-51A0DDDBB5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89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AF56DB-CEE7-E813-7B5B-6564C7666AB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>
            <a:extLst>
              <a:ext uri="{FF2B5EF4-FFF2-40B4-BE49-F238E27FC236}">
                <a16:creationId xmlns:a16="http://schemas.microsoft.com/office/drawing/2014/main" id="{D94146AD-10FD-436C-C6A1-7912B07B29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0588" y="7170199"/>
            <a:ext cx="1795170" cy="128317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08B364A-8587-3B3B-2D44-08228A7CDE2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585" y="2494248"/>
            <a:ext cx="1443354" cy="1909765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15C67DA8-6AE1-F936-CB27-DC529A6937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22989" y="5234094"/>
            <a:ext cx="3992095" cy="3086912"/>
          </a:xfrm>
          <a:prstGeom prst="rect">
            <a:avLst/>
          </a:prstGeom>
        </p:spPr>
      </p:pic>
      <p:grpSp>
        <p:nvGrpSpPr>
          <p:cNvPr id="5" name="Group 4">
            <a:extLst>
              <a:ext uri="{FF2B5EF4-FFF2-40B4-BE49-F238E27FC236}">
                <a16:creationId xmlns:a16="http://schemas.microsoft.com/office/drawing/2014/main" id="{72F7B19D-F452-5F1F-9A13-147F7F359388}"/>
              </a:ext>
            </a:extLst>
          </p:cNvPr>
          <p:cNvGrpSpPr/>
          <p:nvPr/>
        </p:nvGrpSpPr>
        <p:grpSpPr>
          <a:xfrm>
            <a:off x="406124" y="721314"/>
            <a:ext cx="1963359" cy="1598181"/>
            <a:chOff x="826434" y="2234832"/>
            <a:chExt cx="3602750" cy="2968752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0BA0116-BF0B-4A62-C6EF-2EC7939ED0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1918"/>
            <a:stretch/>
          </p:blipFill>
          <p:spPr>
            <a:xfrm>
              <a:off x="826434" y="2234832"/>
              <a:ext cx="3245504" cy="2968752"/>
            </a:xfrm>
            <a:prstGeom prst="rect">
              <a:avLst/>
            </a:prstGeom>
          </p:spPr>
        </p:pic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A9EB98EE-8CAA-6864-CB12-6D9105F9F17F}"/>
                </a:ext>
              </a:extLst>
            </p:cNvPr>
            <p:cNvSpPr/>
            <p:nvPr/>
          </p:nvSpPr>
          <p:spPr>
            <a:xfrm rot="18957572">
              <a:off x="3414772" y="4802821"/>
              <a:ext cx="1014412" cy="36933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656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16F6429-01D0-5992-45B5-89D7B0BD2540}"/>
              </a:ext>
            </a:extLst>
          </p:cNvPr>
          <p:cNvSpPr txBox="1"/>
          <p:nvPr/>
        </p:nvSpPr>
        <p:spPr>
          <a:xfrm>
            <a:off x="-41231" y="1562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068CB8-3D63-4B72-7752-B7A18E9C8B49}"/>
              </a:ext>
            </a:extLst>
          </p:cNvPr>
          <p:cNvSpPr txBox="1"/>
          <p:nvPr/>
        </p:nvSpPr>
        <p:spPr>
          <a:xfrm>
            <a:off x="327462" y="541873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11C64E5-4223-A81D-5754-0F357DFDD3CF}"/>
              </a:ext>
            </a:extLst>
          </p:cNvPr>
          <p:cNvSpPr txBox="1"/>
          <p:nvPr/>
        </p:nvSpPr>
        <p:spPr>
          <a:xfrm>
            <a:off x="2228403" y="533037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E5338A2-78F6-FCF1-7CDF-373E12720A6D}"/>
              </a:ext>
            </a:extLst>
          </p:cNvPr>
          <p:cNvSpPr txBox="1"/>
          <p:nvPr/>
        </p:nvSpPr>
        <p:spPr>
          <a:xfrm>
            <a:off x="4738312" y="505047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7CAB7F8-54EB-76C2-DF9F-26FBC8A1F43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314" y="5043163"/>
            <a:ext cx="1404899" cy="195228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F7463D4-741C-99E4-405E-A5CE0121DD6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29605" y="2902772"/>
            <a:ext cx="2362882" cy="153311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4C11E65-36CC-EBFA-C78B-2305CB4664E0}"/>
              </a:ext>
            </a:extLst>
          </p:cNvPr>
          <p:cNvSpPr txBox="1"/>
          <p:nvPr/>
        </p:nvSpPr>
        <p:spPr>
          <a:xfrm>
            <a:off x="327462" y="5231509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A150BD2-7625-39D5-3BC5-A7A320E3F53B}"/>
              </a:ext>
            </a:extLst>
          </p:cNvPr>
          <p:cNvSpPr txBox="1"/>
          <p:nvPr/>
        </p:nvSpPr>
        <p:spPr>
          <a:xfrm>
            <a:off x="327462" y="7232926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6AE3E00-7FB5-6A2E-D784-59BDFC85044A}"/>
              </a:ext>
            </a:extLst>
          </p:cNvPr>
          <p:cNvSpPr txBox="1"/>
          <p:nvPr/>
        </p:nvSpPr>
        <p:spPr>
          <a:xfrm>
            <a:off x="2469328" y="5234094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71FAC00D-6802-AD1F-F9A6-38B77C00618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8074" y="755325"/>
            <a:ext cx="2359389" cy="1569332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0D2D4D9D-93B1-A68B-EE1A-8DCD9F6E73EA}"/>
              </a:ext>
            </a:extLst>
          </p:cNvPr>
          <p:cNvSpPr txBox="1"/>
          <p:nvPr/>
        </p:nvSpPr>
        <p:spPr>
          <a:xfrm>
            <a:off x="327462" y="2666012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9F44FF-8F33-2C16-681F-27161068B22E}"/>
              </a:ext>
            </a:extLst>
          </p:cNvPr>
          <p:cNvSpPr txBox="1"/>
          <p:nvPr/>
        </p:nvSpPr>
        <p:spPr>
          <a:xfrm>
            <a:off x="4077707" y="2611852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FF5612B-AB03-ACAE-6684-09747535EE60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404" y="2848646"/>
            <a:ext cx="2446311" cy="1479598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5A53E804-B6B1-B0DD-C460-5071C1FF7CC0}"/>
              </a:ext>
            </a:extLst>
          </p:cNvPr>
          <p:cNvSpPr txBox="1"/>
          <p:nvPr/>
        </p:nvSpPr>
        <p:spPr>
          <a:xfrm>
            <a:off x="1822743" y="2629905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513D3F57-6117-9B75-8DDA-E462EF8F25B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964711" y="421811"/>
            <a:ext cx="1169109" cy="1897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8255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2B94A63-176B-2D82-2F56-D708542D82DC}"/>
              </a:ext>
            </a:extLst>
          </p:cNvPr>
          <p:cNvSpPr txBox="1"/>
          <p:nvPr/>
        </p:nvSpPr>
        <p:spPr>
          <a:xfrm>
            <a:off x="501446" y="682612"/>
            <a:ext cx="5338915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. (A)</a:t>
            </a:r>
            <a:r>
              <a:rPr lang="en-GB" sz="1200" dirty="0"/>
              <a:t> Quantification of primary cilium length in fibroblasts isolated from HC (blue) and SSc (red), and VEDOSS (yellow) skin biopsies after serum starvation (n=3-4 donors per group, shown separately). Each value represents a single cilium.</a:t>
            </a:r>
            <a:r>
              <a:rPr lang="en-GB" sz="1200" b="1" dirty="0"/>
              <a:t> (B) </a:t>
            </a:r>
            <a:r>
              <a:rPr lang="en-GB" sz="1200" dirty="0"/>
              <a:t>Primary cilia length distribution in HC (blue) and SSc (red) fibroblasts from individual donors, shown separately. </a:t>
            </a:r>
            <a:r>
              <a:rPr lang="en-GB" sz="1200" b="1" dirty="0"/>
              <a:t>(C) </a:t>
            </a:r>
            <a:r>
              <a:rPr lang="en-GB" sz="1200" dirty="0"/>
              <a:t>Cilia incidence (% ciliated cells) of HC, SSc, and VEDOSS fibroblasts after serum starvation (n=3-4 donors). </a:t>
            </a:r>
            <a:r>
              <a:rPr lang="en-GB" sz="1200" b="1" dirty="0"/>
              <a:t>(D)</a:t>
            </a:r>
            <a:r>
              <a:rPr lang="en-GB" sz="1200" dirty="0"/>
              <a:t> Quantification of cilium length in HC and SSc fibroblasts at passage 2 after isolation from skin biopsies and after immortalisation with hTERT (n=3 donors) </a:t>
            </a:r>
            <a:r>
              <a:rPr lang="en-GB" sz="1200" b="1" dirty="0"/>
              <a:t>(E)</a:t>
            </a:r>
            <a:r>
              <a:rPr lang="en-GB" sz="1200" dirty="0"/>
              <a:t> Cilia incidence of HC and SSc fibroblasts after serum starvation and treatment with 10 ng/ml TGFβ for the indicated time (h). n=3 donors per group. </a:t>
            </a:r>
            <a:r>
              <a:rPr lang="en-GB" sz="1200" b="1" dirty="0"/>
              <a:t>(F)</a:t>
            </a:r>
            <a:r>
              <a:rPr lang="en-GB" sz="1200" dirty="0"/>
              <a:t> Cilium length of primary and immortalised (hTERT) HC and SSc fibroblasts and immortalised VEDOSS fibroblasts treated with exogenous TGFβ for 24 h. n=3 donors per group.</a:t>
            </a:r>
            <a:r>
              <a:rPr lang="en-GB" sz="1200" b="1" dirty="0"/>
              <a:t> (G)</a:t>
            </a:r>
            <a:r>
              <a:rPr lang="en-GB" sz="1200" dirty="0"/>
              <a:t> Quantification of primary cilium length in immortalised HC (blue) and SSc (red) fibroblasts in growth medium (10% serum) or after 24 h of serum starvation (0.5% serum) (n=3 donors per group). </a:t>
            </a:r>
            <a:r>
              <a:rPr lang="en-GB" sz="1200" b="1" dirty="0"/>
              <a:t>(H)</a:t>
            </a:r>
            <a:r>
              <a:rPr lang="en-GB" sz="1200" dirty="0"/>
              <a:t> Quantification of % proliferating cells (Ki67+) in the same conditions as (G). </a:t>
            </a:r>
            <a:r>
              <a:rPr lang="en-GB" sz="1200" b="1" dirty="0"/>
              <a:t>(I)</a:t>
            </a:r>
            <a:r>
              <a:rPr lang="en-GB" sz="1200" dirty="0"/>
              <a:t> Representative immunofluorescence images of Ki67 positive (red) and nuclei (blue, DAPI) in HC and SSc fibroblasts  treated as in (G). All data panels were analysed by ANOVA (ns, non-significant; * P&lt;0.05; ** P&lt;0.01; *** P&lt;0.001; ****P&lt;0.0001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9281806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3E5387-FCA8-4081-EB1B-0D9C7D0F32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4F45ABF-4852-8337-B63B-639B71C57F47}"/>
              </a:ext>
            </a:extLst>
          </p:cNvPr>
          <p:cNvSpPr txBox="1"/>
          <p:nvPr/>
        </p:nvSpPr>
        <p:spPr>
          <a:xfrm>
            <a:off x="274210" y="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1D0B826-34E7-8E23-7584-E0C675791958}"/>
              </a:ext>
            </a:extLst>
          </p:cNvPr>
          <p:cNvSpPr txBox="1"/>
          <p:nvPr/>
        </p:nvSpPr>
        <p:spPr>
          <a:xfrm>
            <a:off x="1776545" y="839861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DCE5F-6FDC-CAE9-2348-0EE280D421A3}"/>
              </a:ext>
            </a:extLst>
          </p:cNvPr>
          <p:cNvSpPr txBox="1"/>
          <p:nvPr/>
        </p:nvSpPr>
        <p:spPr>
          <a:xfrm>
            <a:off x="1744429" y="3794434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57B33D80-05D0-BE8E-9516-473A87F54C4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183" y="753886"/>
            <a:ext cx="2930136" cy="282034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B1F9CF7-717F-7C58-9EFA-9695BD91742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2052" y="4049282"/>
            <a:ext cx="3052073" cy="234449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15CDC7E-CA8A-602C-8146-739DB9B29006}"/>
              </a:ext>
            </a:extLst>
          </p:cNvPr>
          <p:cNvSpPr txBox="1"/>
          <p:nvPr/>
        </p:nvSpPr>
        <p:spPr>
          <a:xfrm>
            <a:off x="792793" y="6790292"/>
            <a:ext cx="533891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2. (A)</a:t>
            </a:r>
            <a:r>
              <a:rPr lang="en-GB" sz="1200" dirty="0"/>
              <a:t> Quantification of primary cilium incidence in HC (blue) and SSc (red) fibroblasts transfected with control siRNA (</a:t>
            </a:r>
            <a:r>
              <a:rPr lang="en-GB" sz="1200" dirty="0" err="1"/>
              <a:t>siSCR</a:t>
            </a:r>
            <a:r>
              <a:rPr lang="en-GB" sz="1200" dirty="0"/>
              <a:t>) or SMAD3 siRNA (siSMAD3) after serum starvation and treatment with 10 ng/ml TGFβ for 24 h (n=3). </a:t>
            </a:r>
            <a:r>
              <a:rPr lang="en-GB" sz="1200" b="1" dirty="0"/>
              <a:t>(B) </a:t>
            </a:r>
            <a:r>
              <a:rPr lang="en-GB" sz="1200" dirty="0"/>
              <a:t>Quantification of primary cilium incidence in HC (blue) and SSc (red) fibroblasts pretreated with vehicle or KD205, followed by treatment with 10 ng/ml TGFβ for 24 h (n=3). All data panels were analysed by ANOVA (ns, non-significant)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437436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BFE6C9-2D13-660B-DE71-B75EA07C66E3}"/>
              </a:ext>
            </a:extLst>
          </p:cNvPr>
          <p:cNvSpPr txBox="1"/>
          <p:nvPr/>
        </p:nvSpPr>
        <p:spPr>
          <a:xfrm>
            <a:off x="274210" y="-23565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FC954F1-BB66-0A23-50BF-0EBEC1519F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3206" y="1272248"/>
            <a:ext cx="3772878" cy="102173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B5295E0-8A9A-D18F-D38D-21FAC2EDCC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27430" y="2606508"/>
            <a:ext cx="2807752" cy="205998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FB29FFF-020C-587D-2B7B-0C07F011AB6A}"/>
              </a:ext>
            </a:extLst>
          </p:cNvPr>
          <p:cNvSpPr txBox="1"/>
          <p:nvPr/>
        </p:nvSpPr>
        <p:spPr>
          <a:xfrm>
            <a:off x="759542" y="6035028"/>
            <a:ext cx="53389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3. (Top)</a:t>
            </a:r>
            <a:r>
              <a:rPr lang="en-GB" sz="1200" dirty="0"/>
              <a:t> Immunoblot of acetylated-</a:t>
            </a:r>
            <a:r>
              <a:rPr lang="en-GB" sz="1200" dirty="0">
                <a:latin typeface="Symbol" pitchFamily="2" charset="2"/>
              </a:rPr>
              <a:t>a</a:t>
            </a:r>
            <a:r>
              <a:rPr lang="en-GB" sz="1200" dirty="0"/>
              <a:t>-tubulin levels in HC and SSc fibroblasts treated with indicated concentrations of Tubacin. </a:t>
            </a:r>
            <a:r>
              <a:rPr lang="en-GB" sz="1200" b="1" dirty="0"/>
              <a:t>(Bottom)</a:t>
            </a:r>
            <a:r>
              <a:rPr lang="en-GB" sz="1200" dirty="0"/>
              <a:t> Densitometric quantification of acetylated-</a:t>
            </a:r>
            <a:r>
              <a:rPr lang="en-GB" sz="1200" dirty="0">
                <a:latin typeface="Symbol" pitchFamily="2" charset="2"/>
              </a:rPr>
              <a:t>a</a:t>
            </a:r>
            <a:r>
              <a:rPr lang="en-GB" sz="1200" dirty="0"/>
              <a:t>-tubulin normalised to </a:t>
            </a:r>
            <a:r>
              <a:rPr lang="en-GB" sz="1200" dirty="0">
                <a:latin typeface="Symbol" pitchFamily="2" charset="2"/>
              </a:rPr>
              <a:t>b</a:t>
            </a:r>
            <a:r>
              <a:rPr lang="en-GB" sz="1200" dirty="0"/>
              <a:t>-actin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0509490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7638BFC-A4D8-8B1F-C9B3-9E3E7A59B7F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98" b="19240"/>
          <a:stretch>
            <a:fillRect/>
          </a:stretch>
        </p:blipFill>
        <p:spPr bwMode="auto">
          <a:xfrm>
            <a:off x="967095" y="639315"/>
            <a:ext cx="4923809" cy="5640648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C6BF386-E667-9F89-2FB6-737F69B50D04}"/>
              </a:ext>
            </a:extLst>
          </p:cNvPr>
          <p:cNvSpPr txBox="1"/>
          <p:nvPr/>
        </p:nvSpPr>
        <p:spPr>
          <a:xfrm>
            <a:off x="274210" y="-23565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7BD72BC-80B5-2B35-36B1-501F2E12478B}"/>
              </a:ext>
            </a:extLst>
          </p:cNvPr>
          <p:cNvSpPr txBox="1"/>
          <p:nvPr/>
        </p:nvSpPr>
        <p:spPr>
          <a:xfrm>
            <a:off x="759541" y="6691733"/>
            <a:ext cx="533891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4. (A)</a:t>
            </a:r>
            <a:r>
              <a:rPr lang="en-GB" sz="1200" dirty="0"/>
              <a:t> Immunofluorescence of phospho-AURKA (red) in HC and SSc fibroblasts treated with vehicle (DMSO) or MLN8054. Cells were counterstained with DAPI (nuclei) and phalloidin (actin fibres). Note reduced intensity of </a:t>
            </a:r>
            <a:r>
              <a:rPr lang="en-GB" sz="1200" dirty="0" err="1"/>
              <a:t>pAURKA</a:t>
            </a:r>
            <a:r>
              <a:rPr lang="en-GB" sz="1200" dirty="0"/>
              <a:t> and defective localisation of the mitotic spindle poles in cells treated with MLN8054. </a:t>
            </a:r>
            <a:r>
              <a:rPr lang="en-GB" sz="1200" b="1" dirty="0"/>
              <a:t>(B)</a:t>
            </a:r>
            <a:r>
              <a:rPr lang="en-GB" sz="1200" dirty="0"/>
              <a:t> Immunofluorescence of phospho-AURKA (red) in HC and SSc fibroblasts (n=3 donors) treated with vehicle (DMSO) or MLN8054. Cells were counterstained with DAPI (nuclei)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131361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B2235A8D-49EB-F952-6BDA-8AB58382248A}"/>
              </a:ext>
            </a:extLst>
          </p:cNvPr>
          <p:cNvSpPr txBox="1"/>
          <p:nvPr/>
        </p:nvSpPr>
        <p:spPr>
          <a:xfrm>
            <a:off x="745508" y="825286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6ECDC85-E8ED-ECCD-DD10-60420AD15F4A}"/>
              </a:ext>
            </a:extLst>
          </p:cNvPr>
          <p:cNvSpPr txBox="1"/>
          <p:nvPr/>
        </p:nvSpPr>
        <p:spPr>
          <a:xfrm>
            <a:off x="2916860" y="810719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4ABEBF3-4BC4-CED8-F5A5-B2870F5D7C56}"/>
              </a:ext>
            </a:extLst>
          </p:cNvPr>
          <p:cNvSpPr txBox="1"/>
          <p:nvPr/>
        </p:nvSpPr>
        <p:spPr>
          <a:xfrm>
            <a:off x="2091391" y="3681438"/>
            <a:ext cx="151897" cy="2622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4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147630-0B8A-C1D6-27B4-C306E411281E}"/>
              </a:ext>
            </a:extLst>
          </p:cNvPr>
          <p:cNvSpPr txBox="1"/>
          <p:nvPr/>
        </p:nvSpPr>
        <p:spPr>
          <a:xfrm>
            <a:off x="274210" y="0"/>
            <a:ext cx="6309580" cy="34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56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DD8DC5B-9217-5110-C6A4-9C0EC1488C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3240" y="3667457"/>
            <a:ext cx="2514937" cy="2562517"/>
          </a:xfrm>
          <a:prstGeom prst="rect">
            <a:avLst/>
          </a:prstGeom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CA3EDCF5-D415-3C95-BFA7-848B50A677EA}"/>
              </a:ext>
            </a:extLst>
          </p:cNvPr>
          <p:cNvGrpSpPr/>
          <p:nvPr/>
        </p:nvGrpSpPr>
        <p:grpSpPr>
          <a:xfrm>
            <a:off x="3222793" y="625007"/>
            <a:ext cx="2580391" cy="2873594"/>
            <a:chOff x="2951882" y="1420223"/>
            <a:chExt cx="2804675" cy="3123363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FDD311C-A76C-5491-5432-DB3558B2080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816"/>
            <a:stretch>
              <a:fillRect/>
            </a:stretch>
          </p:blipFill>
          <p:spPr>
            <a:xfrm>
              <a:off x="2951882" y="2416150"/>
              <a:ext cx="2733531" cy="2127436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D597C80-162F-75BD-8AA6-2C4F0A3944B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477" b="44862"/>
            <a:stretch>
              <a:fillRect/>
            </a:stretch>
          </p:blipFill>
          <p:spPr>
            <a:xfrm>
              <a:off x="3977647" y="1420223"/>
              <a:ext cx="838717" cy="1173026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5BD04D64-8EF5-9432-6616-C3E20C6695D2}"/>
                </a:ext>
              </a:extLst>
            </p:cNvPr>
            <p:cNvSpPr/>
            <p:nvPr/>
          </p:nvSpPr>
          <p:spPr>
            <a:xfrm>
              <a:off x="5495731" y="2733869"/>
              <a:ext cx="260826" cy="79310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656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2F6F2CE-E2BB-BAC8-CE96-6321AB0FBA43}"/>
              </a:ext>
            </a:extLst>
          </p:cNvPr>
          <p:cNvSpPr txBox="1"/>
          <p:nvPr/>
        </p:nvSpPr>
        <p:spPr>
          <a:xfrm>
            <a:off x="792793" y="6790292"/>
            <a:ext cx="533891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5. (A)</a:t>
            </a:r>
            <a:r>
              <a:rPr lang="en-GB" sz="1200" dirty="0"/>
              <a:t> Comparison of primary cilium incidence in HC (blue), SSc (pink),  healthy fibroblasts expressing scrambled shRNA (</a:t>
            </a:r>
            <a:r>
              <a:rPr lang="en-GB" sz="1200" dirty="0" err="1"/>
              <a:t>shSCR</a:t>
            </a:r>
            <a:r>
              <a:rPr lang="en-GB" sz="1200" dirty="0"/>
              <a:t>, green) and healthy fibroblasts expressing CAV1-targeting shRNA (shCAV1, purple) after serum starvation (n=3). </a:t>
            </a:r>
            <a:r>
              <a:rPr lang="en-GB" sz="1200" b="1" dirty="0"/>
              <a:t>(B) </a:t>
            </a:r>
            <a:r>
              <a:rPr lang="en-GB" sz="1200" dirty="0"/>
              <a:t>Primary cilia length distribution in HC (blue), SSc (pink),  healthy fibroblasts expressing scrambled shRNA (</a:t>
            </a:r>
            <a:r>
              <a:rPr lang="en-GB" sz="1200" dirty="0" err="1"/>
              <a:t>shSCR</a:t>
            </a:r>
            <a:r>
              <a:rPr lang="en-GB" sz="1200" dirty="0"/>
              <a:t>, green) and healthy fibroblasts expressing CAV1-targeting shRNA (shCAV1, purple) after serum starvation (n=3). </a:t>
            </a:r>
            <a:r>
              <a:rPr lang="en-GB" sz="1200" b="1" dirty="0"/>
              <a:t>(C) </a:t>
            </a:r>
            <a:r>
              <a:rPr lang="en-GB" sz="1200" dirty="0"/>
              <a:t>Quantification of primary cilium incidence in </a:t>
            </a:r>
            <a:r>
              <a:rPr lang="en-GB" sz="1200" dirty="0" err="1"/>
              <a:t>shSCR</a:t>
            </a:r>
            <a:r>
              <a:rPr lang="en-GB" sz="1200" dirty="0"/>
              <a:t> fibroblasts (green) and shCAV1 fibroblasts (purple) pretreated with vehicle </a:t>
            </a:r>
            <a:r>
              <a:rPr lang="en-GB" sz="1200"/>
              <a:t>or MLN8054, </a:t>
            </a:r>
            <a:r>
              <a:rPr lang="en-GB" sz="1200" dirty="0"/>
              <a:t>followed by treatment with 10 ng/ml TGFβ for 24 h (n=3). All data panels were analysed by ANOVA (ns, non-significant).</a:t>
            </a:r>
          </a:p>
          <a:p>
            <a:endParaRPr lang="en-US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A34E9DD-4A2D-A934-AB05-D60E5EFD65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97827" y="860659"/>
            <a:ext cx="1497643" cy="26755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3930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</TotalTime>
  <Words>750</Words>
  <Application>Microsoft Macintosh PowerPoint</Application>
  <PresentationFormat>Custom</PresentationFormat>
  <Paragraphs>26</Paragraphs>
  <Slides>6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talia Riobo-Del Galdo</dc:creator>
  <cp:lastModifiedBy>Natalia Riobo-Del Galdo</cp:lastModifiedBy>
  <cp:revision>2</cp:revision>
  <dcterms:created xsi:type="dcterms:W3CDTF">2026-01-13T16:47:22Z</dcterms:created>
  <dcterms:modified xsi:type="dcterms:W3CDTF">2026-02-13T09:11:00Z</dcterms:modified>
</cp:coreProperties>
</file>